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234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4!$A$3:$A$11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Sheet4!$B$3:$B$11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4</c:v>
                </c:pt>
                <c:pt idx="3">
                  <c:v>6</c:v>
                </c:pt>
                <c:pt idx="4">
                  <c:v>7</c:v>
                </c:pt>
                <c:pt idx="5">
                  <c:v>17</c:v>
                </c:pt>
                <c:pt idx="6">
                  <c:v>12</c:v>
                </c:pt>
                <c:pt idx="7">
                  <c:v>3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2F-4BF6-AFF9-BD7D63E4EE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9"/>
        <c:axId val="467498272"/>
        <c:axId val="467498600"/>
      </c:barChart>
      <c:catAx>
        <c:axId val="467498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600"/>
        <c:crosses val="autoZero"/>
        <c:auto val="1"/>
        <c:lblAlgn val="ctr"/>
        <c:lblOffset val="100"/>
        <c:noMultiLvlLbl val="0"/>
      </c:catAx>
      <c:valAx>
        <c:axId val="467498600"/>
        <c:scaling>
          <c:orientation val="minMax"/>
          <c:max val="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4!$A$3:$A$11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Sheet4!$C$3:$C$11</c:f>
              <c:numCache>
                <c:formatCode>General</c:formatCode>
                <c:ptCount val="9"/>
                <c:pt idx="0">
                  <c:v>0</c:v>
                </c:pt>
                <c:pt idx="1">
                  <c:v>1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  <c:pt idx="5">
                  <c:v>20</c:v>
                </c:pt>
                <c:pt idx="6">
                  <c:v>11</c:v>
                </c:pt>
                <c:pt idx="7">
                  <c:v>4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21E-4632-922E-F202AC2EAB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9"/>
        <c:axId val="467498272"/>
        <c:axId val="467498600"/>
      </c:barChart>
      <c:catAx>
        <c:axId val="467498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600"/>
        <c:crosses val="autoZero"/>
        <c:auto val="1"/>
        <c:lblAlgn val="ctr"/>
        <c:lblOffset val="100"/>
        <c:noMultiLvlLbl val="0"/>
      </c:catAx>
      <c:valAx>
        <c:axId val="467498600"/>
        <c:scaling>
          <c:orientation val="minMax"/>
          <c:max val="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4!$A$3:$A$11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Sheet4!$D$3:$D$11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</c:v>
                </c:pt>
                <c:pt idx="4">
                  <c:v>9</c:v>
                </c:pt>
                <c:pt idx="5">
                  <c:v>18</c:v>
                </c:pt>
                <c:pt idx="6">
                  <c:v>15</c:v>
                </c:pt>
                <c:pt idx="7">
                  <c:v>3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F4-4BFB-A1F3-2720D11353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9"/>
        <c:axId val="467498272"/>
        <c:axId val="467498600"/>
      </c:barChart>
      <c:catAx>
        <c:axId val="467498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600"/>
        <c:crosses val="autoZero"/>
        <c:auto val="1"/>
        <c:lblAlgn val="ctr"/>
        <c:lblOffset val="100"/>
        <c:noMultiLvlLbl val="0"/>
      </c:catAx>
      <c:valAx>
        <c:axId val="467498600"/>
        <c:scaling>
          <c:orientation val="minMax"/>
          <c:max val="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4!$A$3:$A$11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Sheet4!$E$3:$E$11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6</c:v>
                </c:pt>
                <c:pt idx="4">
                  <c:v>10</c:v>
                </c:pt>
                <c:pt idx="5">
                  <c:v>16</c:v>
                </c:pt>
                <c:pt idx="6">
                  <c:v>8</c:v>
                </c:pt>
                <c:pt idx="7">
                  <c:v>8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78-4FB6-BDEB-86CC99F55F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9"/>
        <c:axId val="467498272"/>
        <c:axId val="467498600"/>
      </c:barChart>
      <c:catAx>
        <c:axId val="467498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600"/>
        <c:crosses val="autoZero"/>
        <c:auto val="1"/>
        <c:lblAlgn val="ctr"/>
        <c:lblOffset val="100"/>
        <c:noMultiLvlLbl val="0"/>
      </c:catAx>
      <c:valAx>
        <c:axId val="467498600"/>
        <c:scaling>
          <c:orientation val="minMax"/>
          <c:max val="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4!$A$3:$A$11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Sheet4!$F$3:$F$11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  <c:pt idx="4">
                  <c:v>8</c:v>
                </c:pt>
                <c:pt idx="5">
                  <c:v>11</c:v>
                </c:pt>
                <c:pt idx="6">
                  <c:v>18</c:v>
                </c:pt>
                <c:pt idx="7">
                  <c:v>7</c:v>
                </c:pt>
                <c:pt idx="8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549-49D8-9AC4-3D68E82F00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9"/>
        <c:axId val="467498272"/>
        <c:axId val="467498600"/>
      </c:barChart>
      <c:catAx>
        <c:axId val="467498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600"/>
        <c:crosses val="autoZero"/>
        <c:auto val="1"/>
        <c:lblAlgn val="ctr"/>
        <c:lblOffset val="100"/>
        <c:noMultiLvlLbl val="0"/>
      </c:catAx>
      <c:valAx>
        <c:axId val="467498600"/>
        <c:scaling>
          <c:orientation val="minMax"/>
          <c:max val="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4!$A$3:$A$11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Sheet4!$G$3:$G$11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  <c:pt idx="4">
                  <c:v>8</c:v>
                </c:pt>
                <c:pt idx="5">
                  <c:v>10</c:v>
                </c:pt>
                <c:pt idx="6">
                  <c:v>19</c:v>
                </c:pt>
                <c:pt idx="7">
                  <c:v>10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97-482B-B69D-42C517A2E6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9"/>
        <c:axId val="467498272"/>
        <c:axId val="467498600"/>
      </c:barChart>
      <c:catAx>
        <c:axId val="467498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600"/>
        <c:crosses val="autoZero"/>
        <c:auto val="1"/>
        <c:lblAlgn val="ctr"/>
        <c:lblOffset val="100"/>
        <c:noMultiLvlLbl val="0"/>
      </c:catAx>
      <c:valAx>
        <c:axId val="467498600"/>
        <c:scaling>
          <c:orientation val="minMax"/>
          <c:max val="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Sheet4!$A$3:$A$11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Sheet4!$H$3:$H$11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5</c:v>
                </c:pt>
                <c:pt idx="4">
                  <c:v>5</c:v>
                </c:pt>
                <c:pt idx="5">
                  <c:v>10</c:v>
                </c:pt>
                <c:pt idx="6">
                  <c:v>23</c:v>
                </c:pt>
                <c:pt idx="7">
                  <c:v>5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BF-43F3-B1A7-D28E28E409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9"/>
        <c:axId val="467498272"/>
        <c:axId val="467498600"/>
      </c:barChart>
      <c:catAx>
        <c:axId val="467498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600"/>
        <c:crosses val="autoZero"/>
        <c:auto val="1"/>
        <c:lblAlgn val="ctr"/>
        <c:lblOffset val="100"/>
        <c:noMultiLvlLbl val="0"/>
      </c:catAx>
      <c:valAx>
        <c:axId val="467498600"/>
        <c:scaling>
          <c:orientation val="minMax"/>
          <c:max val="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67498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5332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2896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417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6652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2589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2835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5404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661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9883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0987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391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3634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8953513-98C5-4C1D-A5D9-D1934CA4CAB6}"/>
              </a:ext>
            </a:extLst>
          </p:cNvPr>
          <p:cNvSpPr txBox="1"/>
          <p:nvPr/>
        </p:nvSpPr>
        <p:spPr>
          <a:xfrm>
            <a:off x="1461718" y="535589"/>
            <a:ext cx="919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201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5CBBAD3-005B-4524-9347-62AA9C668FCE}"/>
              </a:ext>
            </a:extLst>
          </p:cNvPr>
          <p:cNvSpPr txBox="1"/>
          <p:nvPr/>
        </p:nvSpPr>
        <p:spPr>
          <a:xfrm>
            <a:off x="110170" y="31264"/>
            <a:ext cx="2287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0D69A73-B38B-4ADB-9CC3-5F879B2718E2}"/>
              </a:ext>
            </a:extLst>
          </p:cNvPr>
          <p:cNvSpPr txBox="1"/>
          <p:nvPr/>
        </p:nvSpPr>
        <p:spPr>
          <a:xfrm>
            <a:off x="3578784" y="7577541"/>
            <a:ext cx="3128961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V-1 VN titers of 4-year-old horses. The horses from 2011 to 2014 (A to D) received the inactivated vaccine when they were 3-year-old, and those from 2015 to 2017 (E to G) received the modified live vaccine likewise. Numbers of horses for each VN titers in November were indicated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7D47889-66A8-43E7-9F33-19E39AC5AD4C}"/>
              </a:ext>
            </a:extLst>
          </p:cNvPr>
          <p:cNvSpPr txBox="1"/>
          <p:nvPr/>
        </p:nvSpPr>
        <p:spPr>
          <a:xfrm>
            <a:off x="1145014" y="2414567"/>
            <a:ext cx="1546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HV-1 VN titer</a:t>
            </a:r>
            <a:endParaRPr kumimoji="1" lang="ja-JP" altLang="en-US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8755166-97BD-42F9-9432-362F751D0FA0}"/>
              </a:ext>
            </a:extLst>
          </p:cNvPr>
          <p:cNvSpPr txBox="1"/>
          <p:nvPr/>
        </p:nvSpPr>
        <p:spPr>
          <a:xfrm>
            <a:off x="1145014" y="4675399"/>
            <a:ext cx="1546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HV-1 VN titer</a:t>
            </a:r>
            <a:endParaRPr kumimoji="1" lang="ja-JP" altLang="en-US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143B2D7-53C2-4EB8-9BA4-8D297304560B}"/>
              </a:ext>
            </a:extLst>
          </p:cNvPr>
          <p:cNvSpPr txBox="1"/>
          <p:nvPr/>
        </p:nvSpPr>
        <p:spPr>
          <a:xfrm rot="16200000">
            <a:off x="-588921" y="1163366"/>
            <a:ext cx="16831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Number of horses</a:t>
            </a:r>
            <a:endParaRPr kumimoji="1" lang="ja-JP" altLang="en-US" sz="16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4E37D9F-E31D-46B4-A5A3-F5FA6074FC9E}"/>
              </a:ext>
            </a:extLst>
          </p:cNvPr>
          <p:cNvSpPr txBox="1"/>
          <p:nvPr/>
        </p:nvSpPr>
        <p:spPr>
          <a:xfrm rot="16200000">
            <a:off x="-552828" y="3431284"/>
            <a:ext cx="16831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Number of horses</a:t>
            </a:r>
            <a:endParaRPr kumimoji="1" lang="ja-JP" altLang="en-US" sz="1600" dirty="0"/>
          </a:p>
        </p:txBody>
      </p:sp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8D863116-481B-4DB7-A577-2CEE1CE656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9993851"/>
              </p:ext>
            </p:extLst>
          </p:nvPr>
        </p:nvGraphicFramePr>
        <p:xfrm>
          <a:off x="263942" y="461193"/>
          <a:ext cx="3128961" cy="22048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BA71008E-2F97-42FB-B406-ECBEF88331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02685588"/>
              </p:ext>
            </p:extLst>
          </p:nvPr>
        </p:nvGraphicFramePr>
        <p:xfrm>
          <a:off x="282362" y="2715595"/>
          <a:ext cx="3128961" cy="22048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DF90A50-FFDC-4CF9-82C9-CE0B3D940BD1}"/>
              </a:ext>
            </a:extLst>
          </p:cNvPr>
          <p:cNvSpPr txBox="1"/>
          <p:nvPr/>
        </p:nvSpPr>
        <p:spPr>
          <a:xfrm>
            <a:off x="1447440" y="2828590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201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2690AE5B-6B10-4208-B669-D61AB520C90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8976145"/>
              </p:ext>
            </p:extLst>
          </p:nvPr>
        </p:nvGraphicFramePr>
        <p:xfrm>
          <a:off x="263942" y="5042274"/>
          <a:ext cx="3128961" cy="22048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8BCC464-0FEB-4D74-8950-CB84492BD9F3}"/>
              </a:ext>
            </a:extLst>
          </p:cNvPr>
          <p:cNvSpPr txBox="1"/>
          <p:nvPr/>
        </p:nvSpPr>
        <p:spPr>
          <a:xfrm rot="16200000">
            <a:off x="-582844" y="5781946"/>
            <a:ext cx="16831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Number of horses</a:t>
            </a:r>
            <a:endParaRPr kumimoji="1" lang="ja-JP" altLang="en-US" sz="16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B0D6630-F296-444E-9F72-B6ECC1DE67EE}"/>
              </a:ext>
            </a:extLst>
          </p:cNvPr>
          <p:cNvSpPr txBox="1"/>
          <p:nvPr/>
        </p:nvSpPr>
        <p:spPr>
          <a:xfrm>
            <a:off x="1417424" y="5179252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201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867B2CD8-D20F-48A7-ABC5-416F43AEB58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5913613"/>
              </p:ext>
            </p:extLst>
          </p:nvPr>
        </p:nvGraphicFramePr>
        <p:xfrm>
          <a:off x="282362" y="7384355"/>
          <a:ext cx="3128961" cy="22048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469D450-9311-4BDB-BA5A-93340B8356D2}"/>
              </a:ext>
            </a:extLst>
          </p:cNvPr>
          <p:cNvSpPr txBox="1"/>
          <p:nvPr/>
        </p:nvSpPr>
        <p:spPr>
          <a:xfrm>
            <a:off x="1101052" y="6978636"/>
            <a:ext cx="1546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HV-1 VN titer</a:t>
            </a:r>
            <a:endParaRPr kumimoji="1" lang="ja-JP" altLang="en-US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507B422-267E-481E-A796-0D9A88A70472}"/>
              </a:ext>
            </a:extLst>
          </p:cNvPr>
          <p:cNvSpPr txBox="1"/>
          <p:nvPr/>
        </p:nvSpPr>
        <p:spPr>
          <a:xfrm>
            <a:off x="1101052" y="9335734"/>
            <a:ext cx="1546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HV-1 VN titer</a:t>
            </a:r>
            <a:endParaRPr kumimoji="1" lang="ja-JP" altLang="en-US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90AD538-47D9-48C5-B092-EAE03E8A6DF5}"/>
              </a:ext>
            </a:extLst>
          </p:cNvPr>
          <p:cNvSpPr txBox="1"/>
          <p:nvPr/>
        </p:nvSpPr>
        <p:spPr>
          <a:xfrm rot="16200000">
            <a:off x="-552828" y="8132608"/>
            <a:ext cx="16831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Number of horses</a:t>
            </a:r>
            <a:endParaRPr kumimoji="1" lang="ja-JP" altLang="en-US" sz="1600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1D5F555-15E4-4A0C-BFC5-914FB3F702A9}"/>
              </a:ext>
            </a:extLst>
          </p:cNvPr>
          <p:cNvSpPr txBox="1"/>
          <p:nvPr/>
        </p:nvSpPr>
        <p:spPr>
          <a:xfrm>
            <a:off x="1447440" y="7470183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 2014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2FA0B9A-6DBC-4E4D-9134-A94E9F560AF0}"/>
              </a:ext>
            </a:extLst>
          </p:cNvPr>
          <p:cNvSpPr txBox="1"/>
          <p:nvPr/>
        </p:nvSpPr>
        <p:spPr>
          <a:xfrm>
            <a:off x="4792657" y="550548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201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CEE4F82-037F-47CA-8DDC-63A9EB156E11}"/>
              </a:ext>
            </a:extLst>
          </p:cNvPr>
          <p:cNvSpPr txBox="1"/>
          <p:nvPr/>
        </p:nvSpPr>
        <p:spPr>
          <a:xfrm>
            <a:off x="4520247" y="2414566"/>
            <a:ext cx="1546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HV-1 VN titer</a:t>
            </a:r>
            <a:endParaRPr kumimoji="1" lang="ja-JP" altLang="en-US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9AEE85E-F05D-4B93-BF18-C4E9806AA981}"/>
              </a:ext>
            </a:extLst>
          </p:cNvPr>
          <p:cNvSpPr txBox="1"/>
          <p:nvPr/>
        </p:nvSpPr>
        <p:spPr>
          <a:xfrm>
            <a:off x="4520247" y="4675398"/>
            <a:ext cx="1546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HV-1 VN titer</a:t>
            </a:r>
            <a:endParaRPr kumimoji="1" lang="ja-JP" altLang="en-US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774A062-9E72-4A1D-87DD-41A4FCE632FB}"/>
              </a:ext>
            </a:extLst>
          </p:cNvPr>
          <p:cNvSpPr txBox="1"/>
          <p:nvPr/>
        </p:nvSpPr>
        <p:spPr>
          <a:xfrm rot="16200000">
            <a:off x="2786312" y="1163365"/>
            <a:ext cx="16831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Number of horses</a:t>
            </a:r>
            <a:endParaRPr kumimoji="1" lang="ja-JP" altLang="en-US" sz="1600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A32C8052-1ACC-45E9-B907-AEB30AD1D6D6}"/>
              </a:ext>
            </a:extLst>
          </p:cNvPr>
          <p:cNvSpPr txBox="1"/>
          <p:nvPr/>
        </p:nvSpPr>
        <p:spPr>
          <a:xfrm rot="16200000">
            <a:off x="2822405" y="3431283"/>
            <a:ext cx="16831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Number of horses</a:t>
            </a:r>
            <a:endParaRPr kumimoji="1" lang="ja-JP" altLang="en-US" sz="16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FFA34E3-4F66-45E3-84EB-337E9F67DE53}"/>
              </a:ext>
            </a:extLst>
          </p:cNvPr>
          <p:cNvSpPr txBox="1"/>
          <p:nvPr/>
        </p:nvSpPr>
        <p:spPr>
          <a:xfrm>
            <a:off x="4822673" y="2828589"/>
            <a:ext cx="871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. 2016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E762441-4FFC-4BC4-89C4-28EA652EDF2D}"/>
              </a:ext>
            </a:extLst>
          </p:cNvPr>
          <p:cNvSpPr txBox="1"/>
          <p:nvPr/>
        </p:nvSpPr>
        <p:spPr>
          <a:xfrm rot="16200000">
            <a:off x="2792389" y="5781945"/>
            <a:ext cx="16831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/>
              <a:t>Number of horses</a:t>
            </a:r>
            <a:endParaRPr kumimoji="1" lang="ja-JP" altLang="en-US" sz="1600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42266D9-5D8D-45A5-8809-D5251E16A82A}"/>
              </a:ext>
            </a:extLst>
          </p:cNvPr>
          <p:cNvSpPr txBox="1"/>
          <p:nvPr/>
        </p:nvSpPr>
        <p:spPr>
          <a:xfrm>
            <a:off x="4792657" y="5179251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2017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9C52140-F19D-40BE-9DD1-0E0CB2E47C89}"/>
              </a:ext>
            </a:extLst>
          </p:cNvPr>
          <p:cNvSpPr txBox="1"/>
          <p:nvPr/>
        </p:nvSpPr>
        <p:spPr>
          <a:xfrm>
            <a:off x="4476285" y="6978635"/>
            <a:ext cx="1546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HV-1 VN titer</a:t>
            </a:r>
            <a:endParaRPr kumimoji="1" lang="ja-JP" altLang="en-US" dirty="0"/>
          </a:p>
        </p:txBody>
      </p:sp>
      <p:graphicFrame>
        <p:nvGraphicFramePr>
          <p:cNvPr id="39" name="グラフ 38">
            <a:extLst>
              <a:ext uri="{FF2B5EF4-FFF2-40B4-BE49-F238E27FC236}">
                <a16:creationId xmlns:a16="http://schemas.microsoft.com/office/drawing/2014/main" id="{260D02E2-A41A-4036-9630-0311B745A7F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0158127"/>
              </p:ext>
            </p:extLst>
          </p:nvPr>
        </p:nvGraphicFramePr>
        <p:xfrm>
          <a:off x="3629917" y="473224"/>
          <a:ext cx="3128961" cy="22048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0" name="グラフ 39">
            <a:extLst>
              <a:ext uri="{FF2B5EF4-FFF2-40B4-BE49-F238E27FC236}">
                <a16:creationId xmlns:a16="http://schemas.microsoft.com/office/drawing/2014/main" id="{FCA2F612-7B13-48A9-BA13-342D63C764E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1221423"/>
              </p:ext>
            </p:extLst>
          </p:nvPr>
        </p:nvGraphicFramePr>
        <p:xfrm>
          <a:off x="3660354" y="2740852"/>
          <a:ext cx="3128961" cy="21795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5691ED8A-9B95-4F35-A6EC-56CEC3FDA2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1599043"/>
              </p:ext>
            </p:extLst>
          </p:nvPr>
        </p:nvGraphicFramePr>
        <p:xfrm>
          <a:off x="3660353" y="5047746"/>
          <a:ext cx="3128961" cy="2199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676220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</TotalTime>
  <Words>123</Words>
  <Application>Microsoft Office PowerPoint</Application>
  <PresentationFormat>A4 210 x 297 mm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shi Bannai</dc:creator>
  <cp:lastModifiedBy>Hiroshi Bannai</cp:lastModifiedBy>
  <cp:revision>9</cp:revision>
  <cp:lastPrinted>2019-07-22T00:11:22Z</cp:lastPrinted>
  <dcterms:created xsi:type="dcterms:W3CDTF">2019-07-21T22:57:53Z</dcterms:created>
  <dcterms:modified xsi:type="dcterms:W3CDTF">2019-07-22T00:54:30Z</dcterms:modified>
</cp:coreProperties>
</file>